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05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5A7AA-CBB6-4CA5-B52D-46C97A6A403E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A1B00-7CB7-49BA-8E6B-4D78EF6084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8980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5A7AA-CBB6-4CA5-B52D-46C97A6A403E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A1B00-7CB7-49BA-8E6B-4D78EF6084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6597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5A7AA-CBB6-4CA5-B52D-46C97A6A403E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A1B00-7CB7-49BA-8E6B-4D78EF6084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4803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5A7AA-CBB6-4CA5-B52D-46C97A6A403E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A1B00-7CB7-49BA-8E6B-4D78EF6084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0203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5A7AA-CBB6-4CA5-B52D-46C97A6A403E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A1B00-7CB7-49BA-8E6B-4D78EF6084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0573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5A7AA-CBB6-4CA5-B52D-46C97A6A403E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A1B00-7CB7-49BA-8E6B-4D78EF6084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5767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5A7AA-CBB6-4CA5-B52D-46C97A6A403E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A1B00-7CB7-49BA-8E6B-4D78EF6084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4380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5A7AA-CBB6-4CA5-B52D-46C97A6A403E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A1B00-7CB7-49BA-8E6B-4D78EF6084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5969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5A7AA-CBB6-4CA5-B52D-46C97A6A403E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A1B00-7CB7-49BA-8E6B-4D78EF6084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33021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5A7AA-CBB6-4CA5-B52D-46C97A6A403E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A1B00-7CB7-49BA-8E6B-4D78EF6084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9216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5A7AA-CBB6-4CA5-B52D-46C97A6A403E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A1B00-7CB7-49BA-8E6B-4D78EF6084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86854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55A7AA-CBB6-4CA5-B52D-46C97A6A403E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4A1B00-7CB7-49BA-8E6B-4D78EF6084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7707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755576" y="476672"/>
            <a:ext cx="799288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S7 Amino acid sequence alignment of melon </a:t>
            </a:r>
            <a:r>
              <a:rPr lang="en-US" altLang="zh-CN" b="1" i="1" dirty="0"/>
              <a:t>CmADH8</a:t>
            </a:r>
            <a:r>
              <a:rPr lang="en-US" altLang="zh-CN" b="1" dirty="0"/>
              <a:t> (MELO3C003251P1) with closely related sequences of other plants.</a:t>
            </a:r>
            <a:endParaRPr lang="zh-CN" altLang="en-US" dirty="0"/>
          </a:p>
        </p:txBody>
      </p:sp>
      <p:sp>
        <p:nvSpPr>
          <p:cNvPr id="5" name="Rectangle 18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6" name="Group 1"/>
          <p:cNvGrpSpPr>
            <a:grpSpLocks/>
          </p:cNvGrpSpPr>
          <p:nvPr/>
        </p:nvGrpSpPr>
        <p:grpSpPr bwMode="auto">
          <a:xfrm>
            <a:off x="1115068" y="1340768"/>
            <a:ext cx="7129340" cy="2592288"/>
            <a:chOff x="0" y="0"/>
            <a:chExt cx="12152" cy="4905"/>
          </a:xfrm>
        </p:grpSpPr>
        <p:sp>
          <p:nvSpPr>
            <p:cNvPr id="7" name="AutoShape 17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12152" cy="490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2064" name="Picture 16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11878" cy="21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pic>
          <p:nvPicPr>
            <p:cNvPr id="2063" name="Picture 1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2271"/>
              <a:ext cx="11878" cy="211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8" name="Rectangle 14"/>
            <p:cNvSpPr>
              <a:spLocks noChangeArrowheads="1"/>
            </p:cNvSpPr>
            <p:nvPr/>
          </p:nvSpPr>
          <p:spPr bwMode="auto">
            <a:xfrm>
              <a:off x="6151" y="0"/>
              <a:ext cx="2048" cy="2173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Rectangle 13"/>
            <p:cNvSpPr>
              <a:spLocks noChangeArrowheads="1"/>
            </p:cNvSpPr>
            <p:nvPr/>
          </p:nvSpPr>
          <p:spPr bwMode="auto">
            <a:xfrm>
              <a:off x="1171" y="2271"/>
              <a:ext cx="1855" cy="2173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12"/>
            <p:cNvSpPr>
              <a:spLocks noChangeArrowheads="1"/>
            </p:cNvSpPr>
            <p:nvPr/>
          </p:nvSpPr>
          <p:spPr bwMode="auto">
            <a:xfrm>
              <a:off x="9372" y="0"/>
              <a:ext cx="1855" cy="2173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" name="Text Box 11"/>
            <p:cNvSpPr txBox="1">
              <a:spLocks noChangeArrowheads="1"/>
            </p:cNvSpPr>
            <p:nvPr/>
          </p:nvSpPr>
          <p:spPr bwMode="auto">
            <a:xfrm>
              <a:off x="5955" y="2173"/>
              <a:ext cx="2682" cy="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Zn1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2" name="Text Box 10"/>
            <p:cNvSpPr txBox="1">
              <a:spLocks noChangeArrowheads="1"/>
            </p:cNvSpPr>
            <p:nvPr/>
          </p:nvSpPr>
          <p:spPr bwMode="auto">
            <a:xfrm>
              <a:off x="684" y="4443"/>
              <a:ext cx="3027" cy="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Zn2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3" name="Text Box 9"/>
            <p:cNvSpPr txBox="1">
              <a:spLocks noChangeArrowheads="1"/>
            </p:cNvSpPr>
            <p:nvPr/>
          </p:nvSpPr>
          <p:spPr bwMode="auto">
            <a:xfrm>
              <a:off x="9126" y="2173"/>
              <a:ext cx="3026" cy="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Zn2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4" name="Rectangle 8"/>
            <p:cNvSpPr>
              <a:spLocks noChangeArrowheads="1"/>
            </p:cNvSpPr>
            <p:nvPr/>
          </p:nvSpPr>
          <p:spPr bwMode="auto">
            <a:xfrm>
              <a:off x="10740" y="0"/>
              <a:ext cx="389" cy="3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080" tIns="21041" rIns="42080" bIns="2104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5" name="Rectangle 7"/>
            <p:cNvSpPr>
              <a:spLocks noChangeArrowheads="1"/>
            </p:cNvSpPr>
            <p:nvPr/>
          </p:nvSpPr>
          <p:spPr bwMode="auto">
            <a:xfrm>
              <a:off x="1270" y="2271"/>
              <a:ext cx="389" cy="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080" tIns="21041" rIns="42080" bIns="2104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6" name="Rectangle 6"/>
            <p:cNvSpPr>
              <a:spLocks noChangeArrowheads="1"/>
            </p:cNvSpPr>
            <p:nvPr/>
          </p:nvSpPr>
          <p:spPr bwMode="auto">
            <a:xfrm>
              <a:off x="1659" y="2271"/>
              <a:ext cx="391" cy="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080" tIns="21041" rIns="42080" bIns="2104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7" name="Rectangle 5"/>
            <p:cNvSpPr>
              <a:spLocks noChangeArrowheads="1"/>
            </p:cNvSpPr>
            <p:nvPr/>
          </p:nvSpPr>
          <p:spPr bwMode="auto">
            <a:xfrm>
              <a:off x="2732" y="2271"/>
              <a:ext cx="391" cy="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080" tIns="21041" rIns="42080" bIns="2104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8" name="Rectangle 4"/>
            <p:cNvSpPr>
              <a:spLocks noChangeArrowheads="1"/>
            </p:cNvSpPr>
            <p:nvPr/>
          </p:nvSpPr>
          <p:spPr bwMode="auto">
            <a:xfrm>
              <a:off x="6151" y="0"/>
              <a:ext cx="456" cy="3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9" name="Rectangle 3"/>
            <p:cNvSpPr>
              <a:spLocks noChangeArrowheads="1"/>
            </p:cNvSpPr>
            <p:nvPr/>
          </p:nvSpPr>
          <p:spPr bwMode="auto">
            <a:xfrm>
              <a:off x="6247" y="0"/>
              <a:ext cx="456" cy="3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0" name="Rectangle 2"/>
            <p:cNvSpPr>
              <a:spLocks noChangeArrowheads="1"/>
            </p:cNvSpPr>
            <p:nvPr/>
          </p:nvSpPr>
          <p:spPr bwMode="auto">
            <a:xfrm>
              <a:off x="3515" y="0"/>
              <a:ext cx="456" cy="3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sp>
        <p:nvSpPr>
          <p:cNvPr id="21" name="Rectangle 37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22" name="Group 29"/>
          <p:cNvGrpSpPr>
            <a:grpSpLocks/>
          </p:cNvGrpSpPr>
          <p:nvPr/>
        </p:nvGrpSpPr>
        <p:grpSpPr bwMode="auto">
          <a:xfrm>
            <a:off x="1115068" y="3901830"/>
            <a:ext cx="6968590" cy="1399378"/>
            <a:chOff x="0" y="0"/>
            <a:chExt cx="11878" cy="2635"/>
          </a:xfrm>
        </p:grpSpPr>
        <p:sp>
          <p:nvSpPr>
            <p:cNvPr id="23" name="AutoShape 36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11878" cy="263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2083" name="Picture 3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11878" cy="211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24" name="Rectangle 34"/>
            <p:cNvSpPr>
              <a:spLocks noChangeArrowheads="1"/>
            </p:cNvSpPr>
            <p:nvPr/>
          </p:nvSpPr>
          <p:spPr bwMode="auto">
            <a:xfrm>
              <a:off x="4589" y="0"/>
              <a:ext cx="877" cy="2173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" name="Text Box 33"/>
            <p:cNvSpPr txBox="1">
              <a:spLocks noChangeArrowheads="1"/>
            </p:cNvSpPr>
            <p:nvPr/>
          </p:nvSpPr>
          <p:spPr bwMode="auto">
            <a:xfrm>
              <a:off x="3711" y="2173"/>
              <a:ext cx="3513" cy="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NADPH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6" name="Rectangle 32"/>
            <p:cNvSpPr>
              <a:spLocks noChangeArrowheads="1"/>
            </p:cNvSpPr>
            <p:nvPr/>
          </p:nvSpPr>
          <p:spPr bwMode="auto">
            <a:xfrm>
              <a:off x="4589" y="98"/>
              <a:ext cx="218" cy="3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7" name="Rectangle 31"/>
            <p:cNvSpPr>
              <a:spLocks noChangeArrowheads="1"/>
            </p:cNvSpPr>
            <p:nvPr/>
          </p:nvSpPr>
          <p:spPr bwMode="auto">
            <a:xfrm>
              <a:off x="4784" y="98"/>
              <a:ext cx="219" cy="3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8" name="Rectangle 30"/>
            <p:cNvSpPr>
              <a:spLocks noChangeArrowheads="1"/>
            </p:cNvSpPr>
            <p:nvPr/>
          </p:nvSpPr>
          <p:spPr bwMode="auto">
            <a:xfrm>
              <a:off x="5173" y="98"/>
              <a:ext cx="220" cy="3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pic>
        <p:nvPicPr>
          <p:cNvPr id="32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22764" y="6093296"/>
            <a:ext cx="2425700" cy="520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925976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2</Words>
  <Application>Microsoft Office PowerPoint</Application>
  <PresentationFormat>全屏显示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Lenov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C SYSTEM</dc:creator>
  <cp:lastModifiedBy>MC SYSTEM</cp:lastModifiedBy>
  <cp:revision>1</cp:revision>
  <dcterms:created xsi:type="dcterms:W3CDTF">2015-04-21T06:30:00Z</dcterms:created>
  <dcterms:modified xsi:type="dcterms:W3CDTF">2015-04-21T06:31:54Z</dcterms:modified>
</cp:coreProperties>
</file>